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94681"/>
  </p:normalViewPr>
  <p:slideViewPr>
    <p:cSldViewPr snapToGrid="0" snapToObjects="1">
      <p:cViewPr varScale="1">
        <p:scale>
          <a:sx n="70" d="100"/>
          <a:sy n="70" d="100"/>
        </p:scale>
        <p:origin x="15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B8855A4-7576-9444-A088-28184D55024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xmlns="" id="{B775AA29-F3A2-A347-9593-88087A3C92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3B9BEC1-9CFC-D84B-A035-C326403FA2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EABA9573-2DD6-324A-80B5-5F860140AD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0107DDA6-F383-4346-886C-C9665B436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55866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9D77C51C-0707-B242-8E59-02180A8E08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4CA799E4-E9F4-7A4B-A355-C53B504D0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2084D8CA-027B-0949-9FC0-2D3E20E5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1D8D84A4-B54C-E444-86E7-38D8DD21D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30A509BE-1853-914C-8A21-EDD5E724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7607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xmlns="" id="{0A887EB3-8D1F-2245-844E-84FB0A29CC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xmlns="" id="{6B3F2661-1F9C-E24B-952E-0231815D17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D19E2AC8-72E4-FE44-AD38-51FB747EC8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76C796C4-B9FF-1A47-BD99-41AD025F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F75B23C3-CE51-0E4A-B765-EBCFBCB22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0359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2998CD1A-5D12-ED42-9DC0-359204C4D8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B4F7199E-C539-8145-9132-95C236754DF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60896BA8-5D4A-1F4D-898B-D3C1667D13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D4253465-73C4-6748-9F67-43247F4B89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EF016FAE-4161-BA45-99B7-A038CE4D4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0282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871FA1B0-67FA-9A49-B999-95A7998ECC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295E3584-584C-E242-ABFD-BC73ABE6C4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856922CA-15C3-CA4E-9F70-AE2D47B1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05C99BF5-027E-0840-99C4-453D6D4B7A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2EC2CCE8-DA90-DB4F-BE00-B9D87A8FC1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3920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384780B-8882-EB40-B2D2-57419ED48A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EADBC42-8208-804E-BBF3-DDECE2E73E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9FE720D1-3BB5-2F47-92DE-D8BED9C91A7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A871C5E8-001B-BF40-AB98-0AB78AFC3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24E0DE49-CC11-4845-A913-48AE2B52BA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74FFDBCC-2502-4441-BB91-3996F8CD77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523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F202F22A-21A5-FC4B-9BE1-DF1A27004D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B10B69FD-C3DC-754E-8F78-1D38854828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xmlns="" id="{82BD76F1-6893-8443-A37A-0531734F46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xmlns="" id="{C2270550-325B-104F-812E-6EFC041563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xmlns="" id="{194B676D-3FAA-F34E-95FB-CC3B328473B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xmlns="" id="{80BA5CF5-1A34-F144-8EC2-13F62382C7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xmlns="" id="{A445200A-F93E-B849-9DDC-73DE9F84C8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xmlns="" id="{A9251319-D71E-F949-8687-E6949FD2BD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738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6085A3FC-B80A-5949-920E-DE29997A74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xmlns="" id="{4C61BDB5-0654-DF48-95DB-BCB0C88BF7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xmlns="" id="{79EA38C0-F6CF-F045-80B9-E2B6BB0D4F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xmlns="" id="{B35C02A3-8095-7540-A305-69BA2A9D6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0984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xmlns="" id="{2110A6EC-F30D-544E-AAF5-5AB983CD9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xmlns="" id="{14D99BD1-1388-C84F-A807-47DC96ABDC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xmlns="" id="{36B205A1-15E9-0B40-8F26-D8E5D8EF2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27902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C33391A5-9E61-7849-ABF6-19C2F5046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xmlns="" id="{62FF3FBD-E7D8-E04D-921D-127813F8FC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65626BDB-F213-7F41-B1F5-CDE3519584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869E1FB1-39A4-4242-A4C4-23B34EDB49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07D65926-52FD-E24A-85EB-1A39F9AED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889D9E85-4AA2-DF4C-BAE3-437ECD8DE7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56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xmlns="" id="{D416AD43-0238-8C46-9D5A-264C62B410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xmlns="" id="{A56BC605-8904-CA4A-ACA1-8A7F743E9C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xmlns="" id="{21C9D32C-3B5E-154D-ADD1-2413DAA1571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xmlns="" id="{F794E968-2404-8B47-9098-C6800DCDF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xmlns="" id="{9C5DA250-DD9D-9647-9A32-F342FCEFE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xmlns="" id="{A1224765-C90C-3A43-81FE-01A59FCDF4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9537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xmlns="" id="{0093AC9F-E452-1F4A-8A20-B239CD354D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xmlns="" id="{CA72FB79-20AB-7145-9675-D287FB703B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xmlns="" id="{CFE5D8B1-F9C9-044D-A023-C761AF0F5D7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350FE-04C3-054B-80F3-18EC3917CB9D}" type="datetimeFigureOut">
              <a:rPr lang="fr-FR" smtClean="0"/>
              <a:t>31/12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xmlns="" id="{2BF5C8C4-7833-3942-8F58-2343649FD6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xmlns="" id="{B97D9961-4AA5-DA4C-A5AE-3B088CE141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E61E45-31A8-D040-8411-62112375387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677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2EC2F806-A1B3-BF41-A354-5475F5BEA3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2737" y="984289"/>
            <a:ext cx="5092032" cy="4631115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919D04DC-5CB6-864C-AA2B-C9AE3FA258F0}"/>
              </a:ext>
            </a:extLst>
          </p:cNvPr>
          <p:cNvSpPr txBox="1"/>
          <p:nvPr/>
        </p:nvSpPr>
        <p:spPr>
          <a:xfrm>
            <a:off x="836385" y="5879766"/>
            <a:ext cx="110889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dditional file </a:t>
            </a:r>
            <a:r>
              <a:rPr lang="fr-FR" b="1" dirty="0"/>
              <a:t>5</a:t>
            </a:r>
            <a:r>
              <a:rPr lang="fr-FR" dirty="0"/>
              <a:t>. </a:t>
            </a:r>
            <a:r>
              <a:rPr lang="fr-FR" dirty="0" err="1"/>
              <a:t>Correlation</a:t>
            </a:r>
            <a:r>
              <a:rPr lang="fr-FR" dirty="0"/>
              <a:t> </a:t>
            </a:r>
            <a:r>
              <a:rPr lang="fr-FR" dirty="0" err="1"/>
              <a:t>between</a:t>
            </a:r>
            <a:r>
              <a:rPr lang="fr-FR" dirty="0"/>
              <a:t> </a:t>
            </a:r>
            <a:r>
              <a:rPr lang="fr-FR" dirty="0" err="1"/>
              <a:t>baseline</a:t>
            </a:r>
            <a:r>
              <a:rPr lang="fr-FR" dirty="0"/>
              <a:t> IL-6 </a:t>
            </a:r>
            <a:r>
              <a:rPr lang="fr-FR" dirty="0" err="1"/>
              <a:t>levels</a:t>
            </a:r>
            <a:r>
              <a:rPr lang="fr-FR" dirty="0"/>
              <a:t> and SOFA# score on patients </a:t>
            </a:r>
            <a:r>
              <a:rPr lang="fr-FR" dirty="0" err="1"/>
              <a:t>whose</a:t>
            </a:r>
            <a:r>
              <a:rPr lang="fr-FR" dirty="0"/>
              <a:t> time </a:t>
            </a:r>
            <a:r>
              <a:rPr lang="fr-FR" dirty="0" err="1"/>
              <a:t>between</a:t>
            </a:r>
            <a:r>
              <a:rPr lang="fr-FR" dirty="0"/>
              <a:t> </a:t>
            </a:r>
            <a:r>
              <a:rPr lang="fr-FR" dirty="0" err="1"/>
              <a:t>onset</a:t>
            </a:r>
            <a:r>
              <a:rPr lang="fr-FR" dirty="0"/>
              <a:t> </a:t>
            </a:r>
            <a:r>
              <a:rPr lang="fr-FR" dirty="0" err="1"/>
              <a:t>symptoms</a:t>
            </a:r>
            <a:r>
              <a:rPr lang="fr-FR" dirty="0"/>
              <a:t> and </a:t>
            </a:r>
            <a:r>
              <a:rPr lang="fr-FR" dirty="0" err="1"/>
              <a:t>blood</a:t>
            </a:r>
            <a:r>
              <a:rPr lang="fr-FR" dirty="0"/>
              <a:t> </a:t>
            </a:r>
            <a:r>
              <a:rPr lang="fr-FR" dirty="0" err="1"/>
              <a:t>sampling</a:t>
            </a:r>
            <a:r>
              <a:rPr lang="fr-FR" dirty="0"/>
              <a:t> </a:t>
            </a:r>
            <a:r>
              <a:rPr lang="fr-FR" dirty="0" err="1"/>
              <a:t>was</a:t>
            </a:r>
            <a:r>
              <a:rPr lang="fr-FR" dirty="0"/>
              <a:t> 9-19 </a:t>
            </a:r>
            <a:r>
              <a:rPr lang="fr-FR" dirty="0" err="1"/>
              <a:t>days</a:t>
            </a:r>
            <a:r>
              <a:rPr lang="fr-FR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89512420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49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FLOVID</dc:title>
  <dc:creator>Microsoft Office User</dc:creator>
  <cp:lastModifiedBy>Jayapriya V.</cp:lastModifiedBy>
  <cp:revision>107</cp:revision>
  <cp:lastPrinted>2020-06-09T10:13:15Z</cp:lastPrinted>
  <dcterms:created xsi:type="dcterms:W3CDTF">2020-04-22T13:13:56Z</dcterms:created>
  <dcterms:modified xsi:type="dcterms:W3CDTF">2020-12-31T07:10:35Z</dcterms:modified>
</cp:coreProperties>
</file>